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8" r:id="rId2"/>
    <p:sldId id="259" r:id="rId3"/>
    <p:sldId id="260" r:id="rId4"/>
    <p:sldId id="261" r:id="rId5"/>
    <p:sldId id="257" r:id="rId6"/>
  </p:sldIdLst>
  <p:sldSz cx="25199975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606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149997" y="2356703"/>
            <a:ext cx="18899981" cy="5013407"/>
          </a:xfrm>
        </p:spPr>
        <p:txBody>
          <a:bodyPr anchor="b"/>
          <a:lstStyle>
            <a:lvl1pPr algn="ctr">
              <a:defRPr sz="1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997" y="7563446"/>
            <a:ext cx="18899981" cy="3476717"/>
          </a:xfrm>
        </p:spPr>
        <p:txBody>
          <a:bodyPr/>
          <a:lstStyle>
            <a:lvl1pPr marL="0" indent="0" algn="ctr">
              <a:buNone/>
              <a:defRPr sz="4961"/>
            </a:lvl1pPr>
            <a:lvl2pPr marL="944987" indent="0" algn="ctr">
              <a:buNone/>
              <a:defRPr sz="4134"/>
            </a:lvl2pPr>
            <a:lvl3pPr marL="1889973" indent="0" algn="ctr">
              <a:buNone/>
              <a:defRPr sz="3720"/>
            </a:lvl3pPr>
            <a:lvl4pPr marL="2834960" indent="0" algn="ctr">
              <a:buNone/>
              <a:defRPr sz="3307"/>
            </a:lvl4pPr>
            <a:lvl5pPr marL="3779947" indent="0" algn="ctr">
              <a:buNone/>
              <a:defRPr sz="3307"/>
            </a:lvl5pPr>
            <a:lvl6pPr marL="4724933" indent="0" algn="ctr">
              <a:buNone/>
              <a:defRPr sz="3307"/>
            </a:lvl6pPr>
            <a:lvl7pPr marL="5669920" indent="0" algn="ctr">
              <a:buNone/>
              <a:defRPr sz="3307"/>
            </a:lvl7pPr>
            <a:lvl8pPr marL="6614907" indent="0" algn="ctr">
              <a:buNone/>
              <a:defRPr sz="3307"/>
            </a:lvl8pPr>
            <a:lvl9pPr marL="7559893" indent="0" algn="ctr">
              <a:buNone/>
              <a:defRPr sz="3307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235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0744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3732" y="766678"/>
            <a:ext cx="5433745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498" y="766678"/>
            <a:ext cx="15986234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2883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866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374" y="3590055"/>
            <a:ext cx="21734978" cy="5990088"/>
          </a:xfrm>
        </p:spPr>
        <p:txBody>
          <a:bodyPr anchor="b"/>
          <a:lstStyle>
            <a:lvl1pPr>
              <a:defRPr sz="1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374" y="9636811"/>
            <a:ext cx="21734978" cy="3150046"/>
          </a:xfrm>
        </p:spPr>
        <p:txBody>
          <a:bodyPr/>
          <a:lstStyle>
            <a:lvl1pPr marL="0" indent="0">
              <a:buNone/>
              <a:defRPr sz="4961">
                <a:solidFill>
                  <a:schemeClr val="tx1">
                    <a:tint val="75000"/>
                  </a:schemeClr>
                </a:solidFill>
              </a:defRPr>
            </a:lvl1pPr>
            <a:lvl2pPr marL="944987" indent="0">
              <a:buNone/>
              <a:defRPr sz="4134">
                <a:solidFill>
                  <a:schemeClr val="tx1">
                    <a:tint val="75000"/>
                  </a:schemeClr>
                </a:solidFill>
              </a:defRPr>
            </a:lvl2pPr>
            <a:lvl3pPr marL="1889973" indent="0">
              <a:buNone/>
              <a:defRPr sz="3720">
                <a:solidFill>
                  <a:schemeClr val="tx1">
                    <a:tint val="75000"/>
                  </a:schemeClr>
                </a:solidFill>
              </a:defRPr>
            </a:lvl3pPr>
            <a:lvl4pPr marL="283496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4pPr>
            <a:lvl5pPr marL="3779947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5pPr>
            <a:lvl6pPr marL="4724933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6pPr>
            <a:lvl7pPr marL="566992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7pPr>
            <a:lvl8pPr marL="6614907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8pPr>
            <a:lvl9pPr marL="7559893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6813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498" y="3833390"/>
            <a:ext cx="10709989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7488" y="3833390"/>
            <a:ext cx="10709989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20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1" y="766679"/>
            <a:ext cx="21734978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781" y="3530053"/>
            <a:ext cx="10660770" cy="1730025"/>
          </a:xfrm>
        </p:spPr>
        <p:txBody>
          <a:bodyPr anchor="b"/>
          <a:lstStyle>
            <a:lvl1pPr marL="0" indent="0">
              <a:buNone/>
              <a:defRPr sz="4961" b="1"/>
            </a:lvl1pPr>
            <a:lvl2pPr marL="944987" indent="0">
              <a:buNone/>
              <a:defRPr sz="4134" b="1"/>
            </a:lvl2pPr>
            <a:lvl3pPr marL="1889973" indent="0">
              <a:buNone/>
              <a:defRPr sz="3720" b="1"/>
            </a:lvl3pPr>
            <a:lvl4pPr marL="2834960" indent="0">
              <a:buNone/>
              <a:defRPr sz="3307" b="1"/>
            </a:lvl4pPr>
            <a:lvl5pPr marL="3779947" indent="0">
              <a:buNone/>
              <a:defRPr sz="3307" b="1"/>
            </a:lvl5pPr>
            <a:lvl6pPr marL="4724933" indent="0">
              <a:buNone/>
              <a:defRPr sz="3307" b="1"/>
            </a:lvl6pPr>
            <a:lvl7pPr marL="5669920" indent="0">
              <a:buNone/>
              <a:defRPr sz="3307" b="1"/>
            </a:lvl7pPr>
            <a:lvl8pPr marL="6614907" indent="0">
              <a:buNone/>
              <a:defRPr sz="3307" b="1"/>
            </a:lvl8pPr>
            <a:lvl9pPr marL="7559893" indent="0">
              <a:buNone/>
              <a:defRPr sz="330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781" y="5260078"/>
            <a:ext cx="10660770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7487" y="3530053"/>
            <a:ext cx="10713272" cy="1730025"/>
          </a:xfrm>
        </p:spPr>
        <p:txBody>
          <a:bodyPr anchor="b"/>
          <a:lstStyle>
            <a:lvl1pPr marL="0" indent="0">
              <a:buNone/>
              <a:defRPr sz="4961" b="1"/>
            </a:lvl1pPr>
            <a:lvl2pPr marL="944987" indent="0">
              <a:buNone/>
              <a:defRPr sz="4134" b="1"/>
            </a:lvl2pPr>
            <a:lvl3pPr marL="1889973" indent="0">
              <a:buNone/>
              <a:defRPr sz="3720" b="1"/>
            </a:lvl3pPr>
            <a:lvl4pPr marL="2834960" indent="0">
              <a:buNone/>
              <a:defRPr sz="3307" b="1"/>
            </a:lvl4pPr>
            <a:lvl5pPr marL="3779947" indent="0">
              <a:buNone/>
              <a:defRPr sz="3307" b="1"/>
            </a:lvl5pPr>
            <a:lvl6pPr marL="4724933" indent="0">
              <a:buNone/>
              <a:defRPr sz="3307" b="1"/>
            </a:lvl6pPr>
            <a:lvl7pPr marL="5669920" indent="0">
              <a:buNone/>
              <a:defRPr sz="3307" b="1"/>
            </a:lvl7pPr>
            <a:lvl8pPr marL="6614907" indent="0">
              <a:buNone/>
              <a:defRPr sz="3307" b="1"/>
            </a:lvl8pPr>
            <a:lvl9pPr marL="7559893" indent="0">
              <a:buNone/>
              <a:defRPr sz="330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7487" y="5260078"/>
            <a:ext cx="10713272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539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722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410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2" y="960014"/>
            <a:ext cx="8127647" cy="3360050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272" y="2073365"/>
            <a:ext cx="12757487" cy="10233485"/>
          </a:xfrm>
        </p:spPr>
        <p:txBody>
          <a:bodyPr/>
          <a:lstStyle>
            <a:lvl1pPr>
              <a:defRPr sz="6614"/>
            </a:lvl1pPr>
            <a:lvl2pPr>
              <a:defRPr sz="5787"/>
            </a:lvl2pPr>
            <a:lvl3pPr>
              <a:defRPr sz="4961"/>
            </a:lvl3pPr>
            <a:lvl4pPr>
              <a:defRPr sz="4134"/>
            </a:lvl4pPr>
            <a:lvl5pPr>
              <a:defRPr sz="4134"/>
            </a:lvl5pPr>
            <a:lvl6pPr>
              <a:defRPr sz="4134"/>
            </a:lvl6pPr>
            <a:lvl7pPr>
              <a:defRPr sz="4134"/>
            </a:lvl7pPr>
            <a:lvl8pPr>
              <a:defRPr sz="4134"/>
            </a:lvl8pPr>
            <a:lvl9pPr>
              <a:defRPr sz="413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2" y="4320064"/>
            <a:ext cx="8127647" cy="8003453"/>
          </a:xfrm>
        </p:spPr>
        <p:txBody>
          <a:bodyPr/>
          <a:lstStyle>
            <a:lvl1pPr marL="0" indent="0">
              <a:buNone/>
              <a:defRPr sz="3307"/>
            </a:lvl1pPr>
            <a:lvl2pPr marL="944987" indent="0">
              <a:buNone/>
              <a:defRPr sz="2894"/>
            </a:lvl2pPr>
            <a:lvl3pPr marL="1889973" indent="0">
              <a:buNone/>
              <a:defRPr sz="2480"/>
            </a:lvl3pPr>
            <a:lvl4pPr marL="2834960" indent="0">
              <a:buNone/>
              <a:defRPr sz="2067"/>
            </a:lvl4pPr>
            <a:lvl5pPr marL="3779947" indent="0">
              <a:buNone/>
              <a:defRPr sz="2067"/>
            </a:lvl5pPr>
            <a:lvl6pPr marL="4724933" indent="0">
              <a:buNone/>
              <a:defRPr sz="2067"/>
            </a:lvl6pPr>
            <a:lvl7pPr marL="5669920" indent="0">
              <a:buNone/>
              <a:defRPr sz="2067"/>
            </a:lvl7pPr>
            <a:lvl8pPr marL="6614907" indent="0">
              <a:buNone/>
              <a:defRPr sz="2067"/>
            </a:lvl8pPr>
            <a:lvl9pPr marL="7559893" indent="0">
              <a:buNone/>
              <a:defRPr sz="206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590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2" y="960014"/>
            <a:ext cx="8127647" cy="3360050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272" y="2073365"/>
            <a:ext cx="12757487" cy="10233485"/>
          </a:xfrm>
        </p:spPr>
        <p:txBody>
          <a:bodyPr anchor="t"/>
          <a:lstStyle>
            <a:lvl1pPr marL="0" indent="0">
              <a:buNone/>
              <a:defRPr sz="6614"/>
            </a:lvl1pPr>
            <a:lvl2pPr marL="944987" indent="0">
              <a:buNone/>
              <a:defRPr sz="5787"/>
            </a:lvl2pPr>
            <a:lvl3pPr marL="1889973" indent="0">
              <a:buNone/>
              <a:defRPr sz="4961"/>
            </a:lvl3pPr>
            <a:lvl4pPr marL="2834960" indent="0">
              <a:buNone/>
              <a:defRPr sz="4134"/>
            </a:lvl4pPr>
            <a:lvl5pPr marL="3779947" indent="0">
              <a:buNone/>
              <a:defRPr sz="4134"/>
            </a:lvl5pPr>
            <a:lvl6pPr marL="4724933" indent="0">
              <a:buNone/>
              <a:defRPr sz="4134"/>
            </a:lvl6pPr>
            <a:lvl7pPr marL="5669920" indent="0">
              <a:buNone/>
              <a:defRPr sz="4134"/>
            </a:lvl7pPr>
            <a:lvl8pPr marL="6614907" indent="0">
              <a:buNone/>
              <a:defRPr sz="4134"/>
            </a:lvl8pPr>
            <a:lvl9pPr marL="7559893" indent="0">
              <a:buNone/>
              <a:defRPr sz="413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2" y="4320064"/>
            <a:ext cx="8127647" cy="8003453"/>
          </a:xfrm>
        </p:spPr>
        <p:txBody>
          <a:bodyPr/>
          <a:lstStyle>
            <a:lvl1pPr marL="0" indent="0">
              <a:buNone/>
              <a:defRPr sz="3307"/>
            </a:lvl1pPr>
            <a:lvl2pPr marL="944987" indent="0">
              <a:buNone/>
              <a:defRPr sz="2894"/>
            </a:lvl2pPr>
            <a:lvl3pPr marL="1889973" indent="0">
              <a:buNone/>
              <a:defRPr sz="2480"/>
            </a:lvl3pPr>
            <a:lvl4pPr marL="2834960" indent="0">
              <a:buNone/>
              <a:defRPr sz="2067"/>
            </a:lvl4pPr>
            <a:lvl5pPr marL="3779947" indent="0">
              <a:buNone/>
              <a:defRPr sz="2067"/>
            </a:lvl5pPr>
            <a:lvl6pPr marL="4724933" indent="0">
              <a:buNone/>
              <a:defRPr sz="2067"/>
            </a:lvl6pPr>
            <a:lvl7pPr marL="5669920" indent="0">
              <a:buNone/>
              <a:defRPr sz="2067"/>
            </a:lvl7pPr>
            <a:lvl8pPr marL="6614907" indent="0">
              <a:buNone/>
              <a:defRPr sz="2067"/>
            </a:lvl8pPr>
            <a:lvl9pPr marL="7559893" indent="0">
              <a:buNone/>
              <a:defRPr sz="206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15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499" y="766679"/>
            <a:ext cx="21734978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499" y="3833390"/>
            <a:ext cx="21734978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498" y="13346865"/>
            <a:ext cx="566999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FF2B3-8469-4418-A878-8D7A62541148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7492" y="13346865"/>
            <a:ext cx="850499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7483" y="13346865"/>
            <a:ext cx="566999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56770-941B-4BFD-8EC3-D9DF1B4256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1250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889973" rtl="0" eaLnBrk="1" latinLnBrk="0" hangingPunct="1">
        <a:lnSpc>
          <a:spcPct val="90000"/>
        </a:lnSpc>
        <a:spcBef>
          <a:spcPct val="0"/>
        </a:spcBef>
        <a:buNone/>
        <a:defRPr sz="90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2493" indent="-472493" algn="l" defTabSz="1889973" rtl="0" eaLnBrk="1" latinLnBrk="0" hangingPunct="1">
        <a:lnSpc>
          <a:spcPct val="90000"/>
        </a:lnSpc>
        <a:spcBef>
          <a:spcPts val="2067"/>
        </a:spcBef>
        <a:buFont typeface="Arial" panose="020B0604020202020204" pitchFamily="34" charset="0"/>
        <a:buChar char="•"/>
        <a:defRPr sz="5787" kern="1200">
          <a:solidFill>
            <a:schemeClr val="tx1"/>
          </a:solidFill>
          <a:latin typeface="+mn-lt"/>
          <a:ea typeface="+mn-ea"/>
          <a:cs typeface="+mn-cs"/>
        </a:defRPr>
      </a:lvl1pPr>
      <a:lvl2pPr marL="1417480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2pPr>
      <a:lvl3pPr marL="2362467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4134" kern="1200">
          <a:solidFill>
            <a:schemeClr val="tx1"/>
          </a:solidFill>
          <a:latin typeface="+mn-lt"/>
          <a:ea typeface="+mn-ea"/>
          <a:cs typeface="+mn-cs"/>
        </a:defRPr>
      </a:lvl3pPr>
      <a:lvl4pPr marL="3307453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4pPr>
      <a:lvl5pPr marL="4252440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5pPr>
      <a:lvl6pPr marL="5197427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6pPr>
      <a:lvl7pPr marL="6142413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7pPr>
      <a:lvl8pPr marL="7087400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8pPr>
      <a:lvl9pPr marL="8032387" indent="-472493" algn="l" defTabSz="1889973" rtl="0" eaLnBrk="1" latinLnBrk="0" hangingPunct="1">
        <a:lnSpc>
          <a:spcPct val="90000"/>
        </a:lnSpc>
        <a:spcBef>
          <a:spcPts val="1033"/>
        </a:spcBef>
        <a:buFont typeface="Arial" panose="020B0604020202020204" pitchFamily="34" charset="0"/>
        <a:buChar char="•"/>
        <a:defRPr sz="37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1pPr>
      <a:lvl2pPr marL="944987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2pPr>
      <a:lvl3pPr marL="1889973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3pPr>
      <a:lvl4pPr marL="2834960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4pPr>
      <a:lvl5pPr marL="3779947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5pPr>
      <a:lvl6pPr marL="4724933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6pPr>
      <a:lvl7pPr marL="5669920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7pPr>
      <a:lvl8pPr marL="6614907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8pPr>
      <a:lvl9pPr marL="7559893" algn="l" defTabSz="1889973" rtl="0" eaLnBrk="1" latinLnBrk="0" hangingPunct="1">
        <a:defRPr sz="37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47D2E7-4780-5F1E-27C2-BE999E1F64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">
            <a:extLst>
              <a:ext uri="{FF2B5EF4-FFF2-40B4-BE49-F238E27FC236}">
                <a16:creationId xmlns:a16="http://schemas.microsoft.com/office/drawing/2014/main" id="{F16AA92F-6461-7D47-10E6-9046C58C4F87}"/>
              </a:ext>
            </a:extLst>
          </p:cNvPr>
          <p:cNvSpPr txBox="1"/>
          <p:nvPr/>
        </p:nvSpPr>
        <p:spPr>
          <a:xfrm>
            <a:off x="5451177" y="1179871"/>
            <a:ext cx="1567383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4000" b="1" dirty="0">
                <a:solidFill>
                  <a:srgbClr val="0000FF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Table: Summary of original data for Fig 8C</a:t>
            </a:r>
            <a:endParaRPr lang="zh-CN" altLang="en-US" sz="4000" b="1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32C761D1-6DB1-4EE4-FD62-B0C0532B63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1989210"/>
              </p:ext>
            </p:extLst>
          </p:nvPr>
        </p:nvGraphicFramePr>
        <p:xfrm>
          <a:off x="1150372" y="2413779"/>
          <a:ext cx="22417551" cy="8634513"/>
        </p:xfrm>
        <a:graphic>
          <a:graphicData uri="http://schemas.openxmlformats.org/drawingml/2006/table">
            <a:tbl>
              <a:tblPr firstRow="1" firstCol="1" bandRow="1"/>
              <a:tblGrid>
                <a:gridCol w="25063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6020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3090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988027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T file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altLang="zh-CN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ata contents</a:t>
                      </a:r>
                      <a:endParaRPr lang="zh-CN" sz="4000" b="1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altLang="zh-CN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tes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>
                      <a:noFill/>
                    </a:lnL>
                    <a:lnR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8553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lide 1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2159996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ata summary table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 this PPT file, we summarized the original images that require Western blot images of TrxR1, </a:t>
                      </a:r>
                      <a:r>
                        <a:rPr lang="en-US" altLang="zh-CN" sz="4000" kern="100" dirty="0" err="1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x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 in Fig 8C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031678"/>
                  </a:ext>
                </a:extLst>
              </a:tr>
              <a:tr h="1049219">
                <a:tc>
                  <a:txBody>
                    <a:bodyPr/>
                    <a:lstStyle/>
                    <a:p>
                      <a:pPr marL="0" marR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2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ig 8C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xR1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TrxR1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72598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3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8C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kern="100" dirty="0" err="1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x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estern blot images of </a:t>
                      </a:r>
                      <a:r>
                        <a:rPr lang="en-US" altLang="zh-CN" sz="4000" kern="100" dirty="0" err="1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x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67826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4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8C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i="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i="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71311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5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iginal experiment records</a:t>
                      </a:r>
                      <a:endParaRPr lang="zh-CN" altLang="zh-CN" sz="4000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2159996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n 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Figure 8C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 anchor="ctr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31507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927937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ECF1035E-7B99-B100-210D-C42D6D3884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883"/>
          <a:stretch/>
        </p:blipFill>
        <p:spPr>
          <a:xfrm>
            <a:off x="-82161" y="4811890"/>
            <a:ext cx="6902061" cy="29462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4126B3C-C7D6-C4A3-B9B0-5C3516F44731}"/>
              </a:ext>
            </a:extLst>
          </p:cNvPr>
          <p:cNvSpPr txBox="1"/>
          <p:nvPr/>
        </p:nvSpPr>
        <p:spPr>
          <a:xfrm>
            <a:off x="1426170" y="7848582"/>
            <a:ext cx="412746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8C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1AD8E1EA-6694-BB22-B84E-A1A058353CAD}"/>
              </a:ext>
            </a:extLst>
          </p:cNvPr>
          <p:cNvGrpSpPr>
            <a:grpSpLocks noChangeAspect="1"/>
          </p:cNvGrpSpPr>
          <p:nvPr/>
        </p:nvGrpSpPr>
        <p:grpSpPr>
          <a:xfrm>
            <a:off x="12053846" y="6171155"/>
            <a:ext cx="4530871" cy="2691706"/>
            <a:chOff x="7620061" y="3379487"/>
            <a:chExt cx="2518236" cy="1496037"/>
          </a:xfrm>
        </p:grpSpPr>
        <p:pic>
          <p:nvPicPr>
            <p:cNvPr id="235" name="图片 234">
              <a:extLst>
                <a:ext uri="{FF2B5EF4-FFF2-40B4-BE49-F238E27FC236}">
                  <a16:creationId xmlns:a16="http://schemas.microsoft.com/office/drawing/2014/main" id="{AE03362F-9671-63AF-2DE2-2994DC2A1F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33000"/>
                      </a14:imgEffect>
                    </a14:imgLayer>
                  </a14:imgProps>
                </a:ext>
              </a:extLst>
            </a:blip>
            <a:srcRect l="7220" t="7336" r="3901" b="18599"/>
            <a:stretch>
              <a:fillRect/>
            </a:stretch>
          </p:blipFill>
          <p:spPr>
            <a:xfrm flipH="1">
              <a:off x="7620061" y="3379487"/>
              <a:ext cx="2518236" cy="1496037"/>
            </a:xfrm>
            <a:prstGeom prst="rect">
              <a:avLst/>
            </a:prstGeom>
          </p:spPr>
        </p:pic>
        <p:sp>
          <p:nvSpPr>
            <p:cNvPr id="238" name="矩形: 圆角 237">
              <a:extLst>
                <a:ext uri="{FF2B5EF4-FFF2-40B4-BE49-F238E27FC236}">
                  <a16:creationId xmlns:a16="http://schemas.microsoft.com/office/drawing/2014/main" id="{C8695919-9429-F944-3A88-B08532D90D6D}"/>
                </a:ext>
              </a:extLst>
            </p:cNvPr>
            <p:cNvSpPr/>
            <p:nvPr/>
          </p:nvSpPr>
          <p:spPr>
            <a:xfrm>
              <a:off x="8398025" y="4096336"/>
              <a:ext cx="1076078" cy="36260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800"/>
            </a:p>
          </p:txBody>
        </p:sp>
      </p:grpSp>
      <p:pic>
        <p:nvPicPr>
          <p:cNvPr id="240" name="图片 239">
            <a:extLst>
              <a:ext uri="{FF2B5EF4-FFF2-40B4-BE49-F238E27FC236}">
                <a16:creationId xmlns:a16="http://schemas.microsoft.com/office/drawing/2014/main" id="{32812039-B9B2-4B56-AF04-F0C383098F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16851263" y="6117527"/>
            <a:ext cx="4063117" cy="2946265"/>
          </a:xfrm>
          <a:prstGeom prst="rect">
            <a:avLst/>
          </a:prstGeom>
        </p:spPr>
      </p:pic>
      <p:pic>
        <p:nvPicPr>
          <p:cNvPr id="244" name="图片 243">
            <a:extLst>
              <a:ext uri="{FF2B5EF4-FFF2-40B4-BE49-F238E27FC236}">
                <a16:creationId xmlns:a16="http://schemas.microsoft.com/office/drawing/2014/main" id="{14B03835-EBED-08BF-AFAE-64C44E2942B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136859" y="6339368"/>
            <a:ext cx="4063117" cy="2131268"/>
          </a:xfrm>
          <a:prstGeom prst="rect">
            <a:avLst/>
          </a:prstGeom>
        </p:spPr>
      </p:pic>
      <p:sp>
        <p:nvSpPr>
          <p:cNvPr id="246" name="文本框 245">
            <a:extLst>
              <a:ext uri="{FF2B5EF4-FFF2-40B4-BE49-F238E27FC236}">
                <a16:creationId xmlns:a16="http://schemas.microsoft.com/office/drawing/2014/main" id="{372F4F68-0782-E76C-D1F7-C237B7403D71}"/>
              </a:ext>
            </a:extLst>
          </p:cNvPr>
          <p:cNvSpPr txBox="1"/>
          <p:nvPr/>
        </p:nvSpPr>
        <p:spPr>
          <a:xfrm>
            <a:off x="12047182" y="8132185"/>
            <a:ext cx="1773990" cy="806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R1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矩形: 圆角 247">
            <a:extLst>
              <a:ext uri="{FF2B5EF4-FFF2-40B4-BE49-F238E27FC236}">
                <a16:creationId xmlns:a16="http://schemas.microsoft.com/office/drawing/2014/main" id="{ACDC86BB-EAF1-C12A-CFAA-47B4BC77C45B}"/>
              </a:ext>
            </a:extLst>
          </p:cNvPr>
          <p:cNvSpPr/>
          <p:nvPr/>
        </p:nvSpPr>
        <p:spPr>
          <a:xfrm>
            <a:off x="18383800" y="6925177"/>
            <a:ext cx="1658856" cy="55897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49" name="矩形: 圆角 248">
            <a:extLst>
              <a:ext uri="{FF2B5EF4-FFF2-40B4-BE49-F238E27FC236}">
                <a16:creationId xmlns:a16="http://schemas.microsoft.com/office/drawing/2014/main" id="{51F06B03-2380-F68D-3FEC-2782C4172D96}"/>
              </a:ext>
            </a:extLst>
          </p:cNvPr>
          <p:cNvSpPr/>
          <p:nvPr/>
        </p:nvSpPr>
        <p:spPr>
          <a:xfrm>
            <a:off x="21603445" y="7019295"/>
            <a:ext cx="1658856" cy="34210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id="{E1A17187-C208-0BBE-F9C7-078CCCFC5FBC}"/>
              </a:ext>
            </a:extLst>
          </p:cNvPr>
          <p:cNvSpPr txBox="1"/>
          <p:nvPr/>
        </p:nvSpPr>
        <p:spPr>
          <a:xfrm>
            <a:off x="16787586" y="8203950"/>
            <a:ext cx="1773990" cy="806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R1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文本框 253">
            <a:extLst>
              <a:ext uri="{FF2B5EF4-FFF2-40B4-BE49-F238E27FC236}">
                <a16:creationId xmlns:a16="http://schemas.microsoft.com/office/drawing/2014/main" id="{E3629C97-80A2-1027-1481-13BCDA84236D}"/>
              </a:ext>
            </a:extLst>
          </p:cNvPr>
          <p:cNvSpPr txBox="1"/>
          <p:nvPr/>
        </p:nvSpPr>
        <p:spPr>
          <a:xfrm>
            <a:off x="21059537" y="7953117"/>
            <a:ext cx="1773990" cy="806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R1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文本框 238">
            <a:extLst>
              <a:ext uri="{FF2B5EF4-FFF2-40B4-BE49-F238E27FC236}">
                <a16:creationId xmlns:a16="http://schemas.microsoft.com/office/drawing/2014/main" id="{2A78AC0D-A7AF-5335-EE1D-33341B9126BE}"/>
              </a:ext>
            </a:extLst>
          </p:cNvPr>
          <p:cNvSpPr txBox="1"/>
          <p:nvPr/>
        </p:nvSpPr>
        <p:spPr>
          <a:xfrm>
            <a:off x="13527353" y="5736577"/>
            <a:ext cx="13051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文本框 241">
            <a:extLst>
              <a:ext uri="{FF2B5EF4-FFF2-40B4-BE49-F238E27FC236}">
                <a16:creationId xmlns:a16="http://schemas.microsoft.com/office/drawing/2014/main" id="{4D1E15C8-4F6F-A7E3-F232-D61331756928}"/>
              </a:ext>
            </a:extLst>
          </p:cNvPr>
          <p:cNvSpPr txBox="1"/>
          <p:nvPr/>
        </p:nvSpPr>
        <p:spPr>
          <a:xfrm>
            <a:off x="17971455" y="5736577"/>
            <a:ext cx="14045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文本框 249">
            <a:extLst>
              <a:ext uri="{FF2B5EF4-FFF2-40B4-BE49-F238E27FC236}">
                <a16:creationId xmlns:a16="http://schemas.microsoft.com/office/drawing/2014/main" id="{7A22AB4C-A6BC-24F3-6942-BF5A651E82F9}"/>
              </a:ext>
            </a:extLst>
          </p:cNvPr>
          <p:cNvSpPr txBox="1"/>
          <p:nvPr/>
        </p:nvSpPr>
        <p:spPr>
          <a:xfrm>
            <a:off x="22207522" y="5736577"/>
            <a:ext cx="14045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3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A0734C2-29B8-6425-E2C8-204E8B9663AE}"/>
              </a:ext>
            </a:extLst>
          </p:cNvPr>
          <p:cNvSpPr txBox="1"/>
          <p:nvPr/>
        </p:nvSpPr>
        <p:spPr>
          <a:xfrm>
            <a:off x="8996631" y="4382073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6153C1C-F7C1-4A34-C55A-DD0497165B9B}"/>
              </a:ext>
            </a:extLst>
          </p:cNvPr>
          <p:cNvSpPr txBox="1"/>
          <p:nvPr/>
        </p:nvSpPr>
        <p:spPr>
          <a:xfrm>
            <a:off x="16961252" y="4410558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C0315CB4-FC14-6F5F-80E1-49FEDF0C2887}"/>
              </a:ext>
            </a:extLst>
          </p:cNvPr>
          <p:cNvSpPr/>
          <p:nvPr/>
        </p:nvSpPr>
        <p:spPr>
          <a:xfrm>
            <a:off x="1426170" y="5391317"/>
            <a:ext cx="4384080" cy="60687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18FB7A9-A0CA-30AD-7FE4-741A28DDE02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"/>
          <a:stretch>
            <a:fillRect/>
          </a:stretch>
        </p:blipFill>
        <p:spPr>
          <a:xfrm flipH="1">
            <a:off x="7133637" y="6171155"/>
            <a:ext cx="4620503" cy="2884034"/>
          </a:xfrm>
          <a:prstGeom prst="rect">
            <a:avLst/>
          </a:prstGeom>
        </p:spPr>
      </p:pic>
      <p:sp>
        <p:nvSpPr>
          <p:cNvPr id="4" name="矩形: 圆角 3">
            <a:extLst>
              <a:ext uri="{FF2B5EF4-FFF2-40B4-BE49-F238E27FC236}">
                <a16:creationId xmlns:a16="http://schemas.microsoft.com/office/drawing/2014/main" id="{A0A47CD5-B6D2-3E0D-46A8-C586E219F64A}"/>
              </a:ext>
            </a:extLst>
          </p:cNvPr>
          <p:cNvSpPr/>
          <p:nvPr/>
        </p:nvSpPr>
        <p:spPr>
          <a:xfrm>
            <a:off x="7747979" y="6895635"/>
            <a:ext cx="1044473" cy="2820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C351DA7-139C-DA8D-7836-4DCBCE42E174}"/>
              </a:ext>
            </a:extLst>
          </p:cNvPr>
          <p:cNvSpPr txBox="1"/>
          <p:nvPr/>
        </p:nvSpPr>
        <p:spPr>
          <a:xfrm>
            <a:off x="7364418" y="7222544"/>
            <a:ext cx="13257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R1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4928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7B45404C-1164-733F-9B1D-3D62C97B82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8731" y="5820916"/>
            <a:ext cx="4429971" cy="3091985"/>
          </a:xfrm>
          <a:prstGeom prst="rect">
            <a:avLst/>
          </a:prstGeom>
        </p:spPr>
      </p:pic>
      <p:pic>
        <p:nvPicPr>
          <p:cNvPr id="272" name="图片 271">
            <a:extLst>
              <a:ext uri="{FF2B5EF4-FFF2-40B4-BE49-F238E27FC236}">
                <a16:creationId xmlns:a16="http://schemas.microsoft.com/office/drawing/2014/main" id="{44D768AD-3B4E-6946-6DBC-3F0019AAD4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244372" flipH="1">
            <a:off x="17906522" y="5627408"/>
            <a:ext cx="4819782" cy="3479002"/>
          </a:xfrm>
          <a:prstGeom prst="rect">
            <a:avLst/>
          </a:prstGeom>
        </p:spPr>
      </p:pic>
      <p:pic>
        <p:nvPicPr>
          <p:cNvPr id="273" name="图片 272">
            <a:extLst>
              <a:ext uri="{FF2B5EF4-FFF2-40B4-BE49-F238E27FC236}">
                <a16:creationId xmlns:a16="http://schemas.microsoft.com/office/drawing/2014/main" id="{A7E720E7-C59A-B841-054C-ACB1417A8B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60954" y="5745471"/>
            <a:ext cx="4429971" cy="3512829"/>
          </a:xfrm>
          <a:prstGeom prst="rect">
            <a:avLst/>
          </a:prstGeom>
        </p:spPr>
      </p:pic>
      <p:sp>
        <p:nvSpPr>
          <p:cNvPr id="275" name="矩形: 圆角 274">
            <a:extLst>
              <a:ext uri="{FF2B5EF4-FFF2-40B4-BE49-F238E27FC236}">
                <a16:creationId xmlns:a16="http://schemas.microsoft.com/office/drawing/2014/main" id="{2F4CEAD3-23EC-E56C-9255-94D9C57DE00D}"/>
              </a:ext>
            </a:extLst>
          </p:cNvPr>
          <p:cNvSpPr/>
          <p:nvPr/>
        </p:nvSpPr>
        <p:spPr>
          <a:xfrm>
            <a:off x="15539878" y="6703512"/>
            <a:ext cx="1666232" cy="56146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77" name="文本框 276">
            <a:extLst>
              <a:ext uri="{FF2B5EF4-FFF2-40B4-BE49-F238E27FC236}">
                <a16:creationId xmlns:a16="http://schemas.microsoft.com/office/drawing/2014/main" id="{79D8720B-94B1-2686-96D3-436351970688}"/>
              </a:ext>
            </a:extLst>
          </p:cNvPr>
          <p:cNvSpPr txBox="1"/>
          <p:nvPr/>
        </p:nvSpPr>
        <p:spPr>
          <a:xfrm>
            <a:off x="14659615" y="8148770"/>
            <a:ext cx="1069504" cy="810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矩形: 圆角 281">
            <a:extLst>
              <a:ext uri="{FF2B5EF4-FFF2-40B4-BE49-F238E27FC236}">
                <a16:creationId xmlns:a16="http://schemas.microsoft.com/office/drawing/2014/main" id="{9BAB7B8E-5F18-8B8B-19CA-90DCE0899074}"/>
              </a:ext>
            </a:extLst>
          </p:cNvPr>
          <p:cNvSpPr/>
          <p:nvPr/>
        </p:nvSpPr>
        <p:spPr>
          <a:xfrm>
            <a:off x="20316413" y="6614090"/>
            <a:ext cx="1666232" cy="43886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84" name="矩形: 圆角 283">
            <a:extLst>
              <a:ext uri="{FF2B5EF4-FFF2-40B4-BE49-F238E27FC236}">
                <a16:creationId xmlns:a16="http://schemas.microsoft.com/office/drawing/2014/main" id="{C3221977-E5EE-2C79-DCBB-413A32DC9C38}"/>
              </a:ext>
            </a:extLst>
          </p:cNvPr>
          <p:cNvSpPr/>
          <p:nvPr/>
        </p:nvSpPr>
        <p:spPr>
          <a:xfrm>
            <a:off x="20514997" y="7479294"/>
            <a:ext cx="1666232" cy="29736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89" name="文本框 288">
            <a:extLst>
              <a:ext uri="{FF2B5EF4-FFF2-40B4-BE49-F238E27FC236}">
                <a16:creationId xmlns:a16="http://schemas.microsoft.com/office/drawing/2014/main" id="{38D2749B-0166-5E11-D874-C355C88D7D45}"/>
              </a:ext>
            </a:extLst>
          </p:cNvPr>
          <p:cNvSpPr txBox="1"/>
          <p:nvPr/>
        </p:nvSpPr>
        <p:spPr>
          <a:xfrm>
            <a:off x="18261289" y="8325968"/>
            <a:ext cx="1069504" cy="810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文本框 275">
            <a:extLst>
              <a:ext uri="{FF2B5EF4-FFF2-40B4-BE49-F238E27FC236}">
                <a16:creationId xmlns:a16="http://schemas.microsoft.com/office/drawing/2014/main" id="{64D649BC-5D25-27D6-C5A0-B1231F6AC43B}"/>
              </a:ext>
            </a:extLst>
          </p:cNvPr>
          <p:cNvSpPr txBox="1"/>
          <p:nvPr/>
        </p:nvSpPr>
        <p:spPr>
          <a:xfrm>
            <a:off x="16207669" y="6090076"/>
            <a:ext cx="13867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文本框 277">
            <a:extLst>
              <a:ext uri="{FF2B5EF4-FFF2-40B4-BE49-F238E27FC236}">
                <a16:creationId xmlns:a16="http://schemas.microsoft.com/office/drawing/2014/main" id="{95714531-B5C5-F8EE-A4AC-C2597DC244B3}"/>
              </a:ext>
            </a:extLst>
          </p:cNvPr>
          <p:cNvSpPr txBox="1"/>
          <p:nvPr/>
        </p:nvSpPr>
        <p:spPr>
          <a:xfrm>
            <a:off x="22310850" y="6451515"/>
            <a:ext cx="1517525" cy="535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文本框 278">
            <a:extLst>
              <a:ext uri="{FF2B5EF4-FFF2-40B4-BE49-F238E27FC236}">
                <a16:creationId xmlns:a16="http://schemas.microsoft.com/office/drawing/2014/main" id="{07F96ECA-5037-6DC9-9D72-A66CEB1B4E89}"/>
              </a:ext>
            </a:extLst>
          </p:cNvPr>
          <p:cNvSpPr txBox="1"/>
          <p:nvPr/>
        </p:nvSpPr>
        <p:spPr>
          <a:xfrm>
            <a:off x="22310850" y="7241079"/>
            <a:ext cx="1517525" cy="535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3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9377472-C7FE-D249-62B1-1F90F8283FF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8883"/>
          <a:stretch/>
        </p:blipFill>
        <p:spPr>
          <a:xfrm>
            <a:off x="16777" y="4811890"/>
            <a:ext cx="6902061" cy="294626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BC03484-4E49-4070-E956-510364E1764E}"/>
              </a:ext>
            </a:extLst>
          </p:cNvPr>
          <p:cNvSpPr txBox="1"/>
          <p:nvPr/>
        </p:nvSpPr>
        <p:spPr>
          <a:xfrm>
            <a:off x="1407120" y="7848582"/>
            <a:ext cx="412746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8C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C5C9FD0-F6AF-A5BB-9394-A199EF1E3318}"/>
              </a:ext>
            </a:extLst>
          </p:cNvPr>
          <p:cNvSpPr txBox="1"/>
          <p:nvPr/>
        </p:nvSpPr>
        <p:spPr>
          <a:xfrm>
            <a:off x="8977581" y="4744023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7DAC234-7338-E286-F204-F8EC91E31D39}"/>
              </a:ext>
            </a:extLst>
          </p:cNvPr>
          <p:cNvSpPr txBox="1"/>
          <p:nvPr/>
        </p:nvSpPr>
        <p:spPr>
          <a:xfrm>
            <a:off x="16870497" y="4744023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: 圆角 8">
            <a:extLst>
              <a:ext uri="{FF2B5EF4-FFF2-40B4-BE49-F238E27FC236}">
                <a16:creationId xmlns:a16="http://schemas.microsoft.com/office/drawing/2014/main" id="{30CEAC63-C470-332D-B876-DD389E0FF7D1}"/>
              </a:ext>
            </a:extLst>
          </p:cNvPr>
          <p:cNvSpPr/>
          <p:nvPr/>
        </p:nvSpPr>
        <p:spPr>
          <a:xfrm>
            <a:off x="1407120" y="6232080"/>
            <a:ext cx="4384080" cy="60687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4" name="矩形: 圆角 3">
            <a:extLst>
              <a:ext uri="{FF2B5EF4-FFF2-40B4-BE49-F238E27FC236}">
                <a16:creationId xmlns:a16="http://schemas.microsoft.com/office/drawing/2014/main" id="{7D39342F-9723-F1A7-6BD5-0F68FDC2401D}"/>
              </a:ext>
            </a:extLst>
          </p:cNvPr>
          <p:cNvSpPr/>
          <p:nvPr/>
        </p:nvSpPr>
        <p:spPr>
          <a:xfrm>
            <a:off x="10630963" y="6613296"/>
            <a:ext cx="1138528" cy="26193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872223F-8EDB-DA9D-B412-EAA0567B3C32}"/>
              </a:ext>
            </a:extLst>
          </p:cNvPr>
          <p:cNvSpPr txBox="1"/>
          <p:nvPr/>
        </p:nvSpPr>
        <p:spPr>
          <a:xfrm>
            <a:off x="10966821" y="6875233"/>
            <a:ext cx="1069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654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" name="图片 255">
            <a:extLst>
              <a:ext uri="{FF2B5EF4-FFF2-40B4-BE49-F238E27FC236}">
                <a16:creationId xmlns:a16="http://schemas.microsoft.com/office/drawing/2014/main" id="{5EA42B0F-3670-3F73-1FC4-CF06178DA06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13817"/>
          <a:stretch>
            <a:fillRect/>
          </a:stretch>
        </p:blipFill>
        <p:spPr>
          <a:xfrm>
            <a:off x="14116356" y="4363609"/>
            <a:ext cx="5930892" cy="3743977"/>
          </a:xfrm>
          <a:prstGeom prst="rect">
            <a:avLst/>
          </a:prstGeom>
        </p:spPr>
      </p:pic>
      <p:sp>
        <p:nvSpPr>
          <p:cNvPr id="257" name="矩形: 圆角 256">
            <a:extLst>
              <a:ext uri="{FF2B5EF4-FFF2-40B4-BE49-F238E27FC236}">
                <a16:creationId xmlns:a16="http://schemas.microsoft.com/office/drawing/2014/main" id="{1A862789-BE41-626B-1B11-6608C164C7D4}"/>
              </a:ext>
            </a:extLst>
          </p:cNvPr>
          <p:cNvSpPr/>
          <p:nvPr/>
        </p:nvSpPr>
        <p:spPr>
          <a:xfrm>
            <a:off x="16053207" y="5266675"/>
            <a:ext cx="1862492" cy="44732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62" name="矩形: 圆角 261">
            <a:extLst>
              <a:ext uri="{FF2B5EF4-FFF2-40B4-BE49-F238E27FC236}">
                <a16:creationId xmlns:a16="http://schemas.microsoft.com/office/drawing/2014/main" id="{1F8F0AAA-EADA-1013-A106-51C0A759DC66}"/>
              </a:ext>
            </a:extLst>
          </p:cNvPr>
          <p:cNvSpPr/>
          <p:nvPr/>
        </p:nvSpPr>
        <p:spPr>
          <a:xfrm>
            <a:off x="16294845" y="6127881"/>
            <a:ext cx="1862492" cy="44732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/>
          </a:p>
        </p:txBody>
      </p:sp>
      <p:sp>
        <p:nvSpPr>
          <p:cNvPr id="266" name="文本框 265">
            <a:extLst>
              <a:ext uri="{FF2B5EF4-FFF2-40B4-BE49-F238E27FC236}">
                <a16:creationId xmlns:a16="http://schemas.microsoft.com/office/drawing/2014/main" id="{1A4F6FFD-3C16-87D6-47B7-82FBCC07F792}"/>
              </a:ext>
            </a:extLst>
          </p:cNvPr>
          <p:cNvSpPr txBox="1"/>
          <p:nvPr/>
        </p:nvSpPr>
        <p:spPr>
          <a:xfrm>
            <a:off x="14077130" y="7205210"/>
            <a:ext cx="2056295" cy="7378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CAC56E6E-D939-97A7-8339-F8E256CC923E}"/>
              </a:ext>
            </a:extLst>
          </p:cNvPr>
          <p:cNvGrpSpPr>
            <a:grpSpLocks noChangeAspect="1"/>
          </p:cNvGrpSpPr>
          <p:nvPr/>
        </p:nvGrpSpPr>
        <p:grpSpPr>
          <a:xfrm>
            <a:off x="8536602" y="4935190"/>
            <a:ext cx="5577705" cy="3275360"/>
            <a:chOff x="16513330" y="9897402"/>
            <a:chExt cx="2584583" cy="1517728"/>
          </a:xfrm>
        </p:grpSpPr>
        <p:pic>
          <p:nvPicPr>
            <p:cNvPr id="263" name="图片 262">
              <a:extLst>
                <a:ext uri="{FF2B5EF4-FFF2-40B4-BE49-F238E27FC236}">
                  <a16:creationId xmlns:a16="http://schemas.microsoft.com/office/drawing/2014/main" id="{333303CF-5778-A43A-6103-A8CBED369D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513330" y="9897402"/>
              <a:ext cx="2584583" cy="1517728"/>
            </a:xfrm>
            <a:prstGeom prst="rect">
              <a:avLst/>
            </a:prstGeom>
          </p:spPr>
        </p:pic>
        <p:sp>
          <p:nvSpPr>
            <p:cNvPr id="267" name="矩形: 圆角 266">
              <a:extLst>
                <a:ext uri="{FF2B5EF4-FFF2-40B4-BE49-F238E27FC236}">
                  <a16:creationId xmlns:a16="http://schemas.microsoft.com/office/drawing/2014/main" id="{09EDAC26-799A-DA16-16CD-8F85F757568A}"/>
                </a:ext>
              </a:extLst>
            </p:cNvPr>
            <p:cNvSpPr/>
            <p:nvPr/>
          </p:nvSpPr>
          <p:spPr>
            <a:xfrm>
              <a:off x="17859824" y="10368208"/>
              <a:ext cx="688340" cy="317209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800"/>
            </a:p>
          </p:txBody>
        </p:sp>
      </p:grpSp>
      <p:sp>
        <p:nvSpPr>
          <p:cNvPr id="271" name="文本框 270">
            <a:extLst>
              <a:ext uri="{FF2B5EF4-FFF2-40B4-BE49-F238E27FC236}">
                <a16:creationId xmlns:a16="http://schemas.microsoft.com/office/drawing/2014/main" id="{4C981C98-ACB9-2452-E233-03A337E0A8C8}"/>
              </a:ext>
            </a:extLst>
          </p:cNvPr>
          <p:cNvSpPr txBox="1"/>
          <p:nvPr/>
        </p:nvSpPr>
        <p:spPr>
          <a:xfrm>
            <a:off x="8646035" y="7225154"/>
            <a:ext cx="2056295" cy="7378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文本框 259">
            <a:extLst>
              <a:ext uri="{FF2B5EF4-FFF2-40B4-BE49-F238E27FC236}">
                <a16:creationId xmlns:a16="http://schemas.microsoft.com/office/drawing/2014/main" id="{D38EBB2C-71A7-AE33-9FC5-7CD0912FF158}"/>
              </a:ext>
            </a:extLst>
          </p:cNvPr>
          <p:cNvSpPr txBox="1"/>
          <p:nvPr/>
        </p:nvSpPr>
        <p:spPr>
          <a:xfrm>
            <a:off x="18208888" y="5135749"/>
            <a:ext cx="2130174" cy="7378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文本框 260">
            <a:extLst>
              <a:ext uri="{FF2B5EF4-FFF2-40B4-BE49-F238E27FC236}">
                <a16:creationId xmlns:a16="http://schemas.microsoft.com/office/drawing/2014/main" id="{AF7FEC43-2CF2-02D4-997F-29CC99CDDF72}"/>
              </a:ext>
            </a:extLst>
          </p:cNvPr>
          <p:cNvSpPr txBox="1"/>
          <p:nvPr/>
        </p:nvSpPr>
        <p:spPr>
          <a:xfrm>
            <a:off x="18264294" y="6008928"/>
            <a:ext cx="2558853" cy="7378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3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文本框 264">
            <a:extLst>
              <a:ext uri="{FF2B5EF4-FFF2-40B4-BE49-F238E27FC236}">
                <a16:creationId xmlns:a16="http://schemas.microsoft.com/office/drawing/2014/main" id="{9E06F664-7B08-184E-347C-E9B446F40EC2}"/>
              </a:ext>
            </a:extLst>
          </p:cNvPr>
          <p:cNvSpPr txBox="1"/>
          <p:nvPr/>
        </p:nvSpPr>
        <p:spPr>
          <a:xfrm>
            <a:off x="12927912" y="5938399"/>
            <a:ext cx="14854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872967B-4A9A-031C-E273-14FF947DC08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683" t="8883"/>
          <a:stretch>
            <a:fillRect/>
          </a:stretch>
        </p:blipFill>
        <p:spPr>
          <a:xfrm>
            <a:off x="333829" y="4811890"/>
            <a:ext cx="6371771" cy="29462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B0014DE-DB86-13B7-73B0-361959162853}"/>
              </a:ext>
            </a:extLst>
          </p:cNvPr>
          <p:cNvSpPr txBox="1"/>
          <p:nvPr/>
        </p:nvSpPr>
        <p:spPr>
          <a:xfrm>
            <a:off x="1311870" y="7848582"/>
            <a:ext cx="412746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8C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3BFDB16-34EB-BC2D-00EE-905C73A790C0}"/>
              </a:ext>
            </a:extLst>
          </p:cNvPr>
          <p:cNvSpPr txBox="1"/>
          <p:nvPr/>
        </p:nvSpPr>
        <p:spPr>
          <a:xfrm>
            <a:off x="12476807" y="3866950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79161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87C5DA5-A21F-46DA-E791-B3A3EDC61905}"/>
              </a:ext>
            </a:extLst>
          </p:cNvPr>
          <p:cNvSpPr txBox="1"/>
          <p:nvPr/>
        </p:nvSpPr>
        <p:spPr>
          <a:xfrm>
            <a:off x="3090755" y="1364146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1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7C9353A-3B95-ED1C-2E57-5F2E5091A0F4}"/>
              </a:ext>
            </a:extLst>
          </p:cNvPr>
          <p:cNvSpPr txBox="1"/>
          <p:nvPr/>
        </p:nvSpPr>
        <p:spPr>
          <a:xfrm>
            <a:off x="18139049" y="7131913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2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8C3DD17-372A-5FE4-C82F-FA3832C6DFFE}"/>
              </a:ext>
            </a:extLst>
          </p:cNvPr>
          <p:cNvSpPr txBox="1"/>
          <p:nvPr/>
        </p:nvSpPr>
        <p:spPr>
          <a:xfrm>
            <a:off x="18139049" y="11208082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3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60111AA-65F8-BC6F-1995-03BE8F16C2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0755" y="2895927"/>
            <a:ext cx="14780449" cy="988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5257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14</TotalTime>
  <Words>160</Words>
  <Application>Microsoft Office PowerPoint</Application>
  <PresentationFormat>自定义</PresentationFormat>
  <Paragraphs>48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7</dc:creator>
  <cp:lastModifiedBy>hq Lai</cp:lastModifiedBy>
  <cp:revision>34</cp:revision>
  <dcterms:created xsi:type="dcterms:W3CDTF">2025-08-31T12:52:00Z</dcterms:created>
  <dcterms:modified xsi:type="dcterms:W3CDTF">2025-11-13T01:46:58Z</dcterms:modified>
</cp:coreProperties>
</file>